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1218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92B64C-92A6-4443-B744-C4E22BEFE740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FB836-0BA7-452A-9E59-68529ED7D3CE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2969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l-G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l-G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1947D-1B65-4F10-B07A-85B11A127EFF}" type="datetimeFigureOut">
              <a:rPr lang="el-GR" smtClean="0"/>
              <a:t>6/7/201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6DBC70-8E50-42A8-A586-D473BA741B66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55" y="758970"/>
            <a:ext cx="6729691" cy="46980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12283" y="6321152"/>
            <a:ext cx="49145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. Figur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lavonoid biosynthesis pathway as retrieved from KEGG databas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nzymes 6'-deoxychalcone synthas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(E.C. number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3.1.170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halco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flavanon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somerase (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.C. number 5.5.1.6)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ihydroflavono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4-reductase (E.C. number 1.1.1.219)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re highlighted in blue, red and green respectively.</a:t>
            </a:r>
            <a:endParaRPr lang="el-G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6171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3.PPTX</DocumentId>
    <DocumentType xmlns="370fed10-a368-469c-a864-2e77a9536334">Presentation</DocumentType>
    <TitleName xmlns="370fed10-a368-469c-a864-2e77a9536334">Presentation 3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A69F03D0-BBFE-45A8-83A5-8AFB1155E896}"/>
</file>

<file path=customXml/itemProps2.xml><?xml version="1.0" encoding="utf-8"?>
<ds:datastoreItem xmlns:ds="http://schemas.openxmlformats.org/officeDocument/2006/customXml" ds:itemID="{BD7FAC30-58A9-4D2B-B6B7-3B7C753E2949}"/>
</file>

<file path=customXml/itemProps3.xml><?xml version="1.0" encoding="utf-8"?>
<ds:datastoreItem xmlns:ds="http://schemas.openxmlformats.org/officeDocument/2006/customXml" ds:itemID="{8E32E30B-3760-47DF-9FA0-45CA5670331C}"/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53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pasia</dc:creator>
  <cp:lastModifiedBy>Koudounas</cp:lastModifiedBy>
  <cp:revision>18</cp:revision>
  <dcterms:created xsi:type="dcterms:W3CDTF">2013-04-30T09:15:21Z</dcterms:created>
  <dcterms:modified xsi:type="dcterms:W3CDTF">2015-07-06T14:56:37Z</dcterms:modified>
</cp:coreProperties>
</file>